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152BC-8EE7-4965-AAC6-EA665E1006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6BB6FC-9B6C-492C-BA73-DB7728BAFF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6E3B6D-2939-4D28-B9CF-F022FCE21D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CE633-1E7C-4188-8334-1390E18087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DCF05-3D23-46D8-9E9B-AE46CA7618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502E7C-55E7-441F-9C0E-7067C4D331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ABA11-0EC1-4B3F-B6FB-9FD4AD71B5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AF22E-AA17-4547-AF74-AFCE91816A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09E06B-DA6F-4043-AB11-01202608D6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CDE61-B006-414A-84A8-3277E5464E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B11FC9-3258-4AE2-B17C-A1C3443AEF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5ACF9-7591-4F79-9C63-8FD38ED420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C43E1E-B8C8-47A4-98C1-D22BD8D9C36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09600" y="3166920"/>
            <a:ext cx="6238800" cy="2152440"/>
            <a:chOff x="309600" y="3166920"/>
            <a:chExt cx="6238800" cy="2152440"/>
          </a:xfrm>
        </p:grpSpPr>
        <p:graphicFrame>
          <p:nvGraphicFramePr>
            <p:cNvPr id="42" name=""/>
            <p:cNvGraphicFramePr/>
            <p:nvPr/>
          </p:nvGraphicFramePr>
          <p:xfrm>
            <a:off x="309600" y="3166920"/>
            <a:ext cx="6238800" cy="21524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09600" y="3166920"/>
                      <a:ext cx="6238800" cy="2152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>
              <a:off x="333360" y="3519360"/>
              <a:ext cx="792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Times New Roman"/>
                </a:rPr>
                <a:t>sampl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"/>
          <p:cNvSpPr/>
          <p:nvPr/>
        </p:nvSpPr>
        <p:spPr>
          <a:xfrm>
            <a:off x="333360" y="2700360"/>
            <a:ext cx="612000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Table S1.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Means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± SEM of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r>
              <a:rPr b="0" lang="it-IT" sz="1200" spc="-1" strike="noStrike" baseline="-25000">
                <a:solidFill>
                  <a:srgbClr val="000000"/>
                </a:solidFill>
                <a:latin typeface="Times New Roman"/>
              </a:rPr>
              <a:t>T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 value for the three housekeeping genes</a:t>
            </a: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tested in the samples us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7T13:33:06Z</dcterms:created>
  <dc:creator>DB</dc:creator>
  <dc:description/>
  <dc:language>en-US</dc:language>
  <cp:lastModifiedBy>DB</cp:lastModifiedBy>
  <dcterms:modified xsi:type="dcterms:W3CDTF">2013-10-10T09:21:04Z</dcterms:modified>
  <cp:revision>14</cp:revision>
  <dc:subject/>
  <dc:title>Diapositiva 1</dc:title>
</cp:coreProperties>
</file>